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73C60A-CE70-4AC2-A24A-640B2723D0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F9319-39AC-453D-AABD-8A3551491F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DE9177-BD3A-4D5D-A85A-58C621F977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E3AFDC-527F-49A0-9467-7E96C1F003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CC7D63-6604-4999-81BB-EA81E31B00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2003E-8258-46F5-AA5C-DCE3D752C6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1CF60-7691-4E65-942A-6E95551DD0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A6C6B-4E01-41CE-87D7-679183C387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47881-B756-4987-8FA3-B5D3F0F7B4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00382F-8874-4214-8CEA-2853C8A754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7C04E-423D-4C15-8EC7-03B3EEDE43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FC63F6-4CB6-49BC-B7C4-1494C3757D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89E759-C84E-4463-9A6D-E3EA60CD3BD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7" descr=""/>
          <p:cNvPicPr/>
          <p:nvPr/>
        </p:nvPicPr>
        <p:blipFill>
          <a:blip r:embed="rId1"/>
          <a:srcRect l="5505" t="54324" r="3424" b="1216"/>
          <a:stretch/>
        </p:blipFill>
        <p:spPr>
          <a:xfrm>
            <a:off x="1474920" y="3662280"/>
            <a:ext cx="3754440" cy="1943280"/>
          </a:xfrm>
          <a:prstGeom prst="rect">
            <a:avLst/>
          </a:prstGeom>
          <a:ln w="0">
            <a:noFill/>
          </a:ln>
        </p:spPr>
      </p:pic>
      <p:sp>
        <p:nvSpPr>
          <p:cNvPr id="42" name="CasellaDiTesto 6"/>
          <p:cNvSpPr/>
          <p:nvPr/>
        </p:nvSpPr>
        <p:spPr>
          <a:xfrm rot="19140600">
            <a:off x="1270440" y="5597280"/>
            <a:ext cx="59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NOTCH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CasellaDiTesto 7"/>
          <p:cNvSpPr/>
          <p:nvPr/>
        </p:nvSpPr>
        <p:spPr>
          <a:xfrm rot="19140600">
            <a:off x="1664280" y="555912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CDK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CasellaDiTesto 8"/>
          <p:cNvSpPr/>
          <p:nvPr/>
        </p:nvSpPr>
        <p:spPr>
          <a:xfrm rot="19140600">
            <a:off x="1866960" y="5582880"/>
            <a:ext cx="54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S100A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CasellaDiTesto 9"/>
          <p:cNvSpPr/>
          <p:nvPr/>
        </p:nvSpPr>
        <p:spPr>
          <a:xfrm rot="19140600">
            <a:off x="2293560" y="5539680"/>
            <a:ext cx="36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C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CasellaDiTesto 10"/>
          <p:cNvSpPr/>
          <p:nvPr/>
        </p:nvSpPr>
        <p:spPr>
          <a:xfrm rot="19140600">
            <a:off x="2460240" y="5576400"/>
            <a:ext cx="49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PVT1-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CasellaDiTesto 11"/>
          <p:cNvSpPr/>
          <p:nvPr/>
        </p:nvSpPr>
        <p:spPr>
          <a:xfrm rot="19140600">
            <a:off x="2737080" y="5577840"/>
            <a:ext cx="51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FGFR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CasellaDiTesto 12"/>
          <p:cNvSpPr/>
          <p:nvPr/>
        </p:nvSpPr>
        <p:spPr>
          <a:xfrm rot="19140600">
            <a:off x="2932920" y="5598720"/>
            <a:ext cx="599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S100A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CasellaDiTesto 13"/>
          <p:cNvSpPr/>
          <p:nvPr/>
        </p:nvSpPr>
        <p:spPr>
          <a:xfrm rot="19140600">
            <a:off x="3225960" y="5592240"/>
            <a:ext cx="57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MAD1L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asellaDiTesto 14"/>
          <p:cNvSpPr/>
          <p:nvPr/>
        </p:nvSpPr>
        <p:spPr>
          <a:xfrm rot="19140600">
            <a:off x="3546360" y="5581440"/>
            <a:ext cx="52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PVT1-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CasellaDiTesto 15"/>
          <p:cNvSpPr/>
          <p:nvPr/>
        </p:nvSpPr>
        <p:spPr>
          <a:xfrm rot="19140600">
            <a:off x="3870360" y="5562000"/>
            <a:ext cx="47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RAR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CasellaDiTesto 16"/>
          <p:cNvSpPr/>
          <p:nvPr/>
        </p:nvSpPr>
        <p:spPr>
          <a:xfrm rot="19140600">
            <a:off x="4176360" y="555732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RXR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CasellaDiTesto 17"/>
          <p:cNvSpPr/>
          <p:nvPr/>
        </p:nvSpPr>
        <p:spPr>
          <a:xfrm rot="19140600">
            <a:off x="4443120" y="5574600"/>
            <a:ext cx="48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FANC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CasellaDiTesto 20"/>
          <p:cNvSpPr/>
          <p:nvPr/>
        </p:nvSpPr>
        <p:spPr>
          <a:xfrm>
            <a:off x="1156680" y="3598920"/>
            <a:ext cx="326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7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CasellaDiTesto 21"/>
          <p:cNvSpPr/>
          <p:nvPr/>
        </p:nvSpPr>
        <p:spPr>
          <a:xfrm>
            <a:off x="1156680" y="3767040"/>
            <a:ext cx="326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6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CasellaDiTesto 22"/>
          <p:cNvSpPr/>
          <p:nvPr/>
        </p:nvSpPr>
        <p:spPr>
          <a:xfrm>
            <a:off x="1207800" y="41306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7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CasellaDiTesto 23"/>
          <p:cNvSpPr/>
          <p:nvPr/>
        </p:nvSpPr>
        <p:spPr>
          <a:xfrm>
            <a:off x="1207800" y="43210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CasellaDiTesto 24"/>
          <p:cNvSpPr/>
          <p:nvPr/>
        </p:nvSpPr>
        <p:spPr>
          <a:xfrm>
            <a:off x="1207800" y="44974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CasellaDiTesto 25"/>
          <p:cNvSpPr/>
          <p:nvPr/>
        </p:nvSpPr>
        <p:spPr>
          <a:xfrm>
            <a:off x="1207800" y="46879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CasellaDiTesto 26"/>
          <p:cNvSpPr/>
          <p:nvPr/>
        </p:nvSpPr>
        <p:spPr>
          <a:xfrm>
            <a:off x="1207800" y="486252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asellaDiTesto 27"/>
          <p:cNvSpPr/>
          <p:nvPr/>
        </p:nvSpPr>
        <p:spPr>
          <a:xfrm>
            <a:off x="1207800" y="504684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CasellaDiTesto 28"/>
          <p:cNvSpPr/>
          <p:nvPr/>
        </p:nvSpPr>
        <p:spPr>
          <a:xfrm>
            <a:off x="1207800" y="522936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CasellaDiTesto 29"/>
          <p:cNvSpPr/>
          <p:nvPr/>
        </p:nvSpPr>
        <p:spPr>
          <a:xfrm>
            <a:off x="1256040" y="541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asellaDiTesto 31"/>
          <p:cNvSpPr/>
          <p:nvPr/>
        </p:nvSpPr>
        <p:spPr>
          <a:xfrm>
            <a:off x="1207800" y="21528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1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CasellaDiTesto 32"/>
          <p:cNvSpPr/>
          <p:nvPr/>
        </p:nvSpPr>
        <p:spPr>
          <a:xfrm>
            <a:off x="1207800" y="23302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1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asellaDiTesto 33"/>
          <p:cNvSpPr/>
          <p:nvPr/>
        </p:nvSpPr>
        <p:spPr>
          <a:xfrm>
            <a:off x="1207800" y="252396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CasellaDiTesto 34"/>
          <p:cNvSpPr/>
          <p:nvPr/>
        </p:nvSpPr>
        <p:spPr>
          <a:xfrm>
            <a:off x="1256760" y="270504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CasellaDiTesto 35"/>
          <p:cNvSpPr/>
          <p:nvPr/>
        </p:nvSpPr>
        <p:spPr>
          <a:xfrm>
            <a:off x="1256760" y="287352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CasellaDiTesto 36"/>
          <p:cNvSpPr/>
          <p:nvPr/>
        </p:nvSpPr>
        <p:spPr>
          <a:xfrm>
            <a:off x="1256760" y="307980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asellaDiTesto 37"/>
          <p:cNvSpPr/>
          <p:nvPr/>
        </p:nvSpPr>
        <p:spPr>
          <a:xfrm>
            <a:off x="1256760" y="325440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CasellaDiTesto 38"/>
          <p:cNvSpPr/>
          <p:nvPr/>
        </p:nvSpPr>
        <p:spPr>
          <a:xfrm rot="16200000">
            <a:off x="528120" y="2558880"/>
            <a:ext cx="1322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Fold enrichment over Flag 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CasellaDiTesto 39"/>
          <p:cNvSpPr/>
          <p:nvPr/>
        </p:nvSpPr>
        <p:spPr>
          <a:xfrm>
            <a:off x="1207800" y="159876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CasellaDiTesto 40"/>
          <p:cNvSpPr/>
          <p:nvPr/>
        </p:nvSpPr>
        <p:spPr>
          <a:xfrm>
            <a:off x="1207800" y="178128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1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CasellaDiTesto 41"/>
          <p:cNvSpPr/>
          <p:nvPr/>
        </p:nvSpPr>
        <p:spPr>
          <a:xfrm>
            <a:off x="1207800" y="1962000"/>
            <a:ext cx="27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1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CasellaDiTesto 42"/>
          <p:cNvSpPr/>
          <p:nvPr/>
        </p:nvSpPr>
        <p:spPr>
          <a:xfrm>
            <a:off x="1256760" y="3435480"/>
            <a:ext cx="229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Connettore 1 48"/>
          <p:cNvSpPr/>
          <p:nvPr/>
        </p:nvSpPr>
        <p:spPr>
          <a:xfrm>
            <a:off x="1486080" y="5902200"/>
            <a:ext cx="649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Connettore 1 50"/>
          <p:cNvSpPr/>
          <p:nvPr/>
        </p:nvSpPr>
        <p:spPr>
          <a:xfrm>
            <a:off x="2354400" y="5904000"/>
            <a:ext cx="649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Connettore 1 51"/>
          <p:cNvSpPr/>
          <p:nvPr/>
        </p:nvSpPr>
        <p:spPr>
          <a:xfrm flipV="1">
            <a:off x="3260880" y="5900400"/>
            <a:ext cx="155556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CasellaDiTesto 53"/>
          <p:cNvSpPr/>
          <p:nvPr/>
        </p:nvSpPr>
        <p:spPr>
          <a:xfrm>
            <a:off x="1550880" y="5872320"/>
            <a:ext cx="63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mutp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CasellaDiTesto 54"/>
          <p:cNvSpPr/>
          <p:nvPr/>
        </p:nvSpPr>
        <p:spPr>
          <a:xfrm>
            <a:off x="2493720" y="5872320"/>
            <a:ext cx="39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p6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CasellaDiTesto 55"/>
          <p:cNvSpPr/>
          <p:nvPr/>
        </p:nvSpPr>
        <p:spPr>
          <a:xfrm>
            <a:off x="3634920" y="5872320"/>
            <a:ext cx="88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mutp53/p6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CasellaDiTesto 43"/>
          <p:cNvSpPr/>
          <p:nvPr/>
        </p:nvSpPr>
        <p:spPr>
          <a:xfrm>
            <a:off x="5260320" y="335124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  <a:ea typeface="Arial"/>
              </a:rPr>
              <a:t>p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CasellaDiTesto 44"/>
          <p:cNvSpPr/>
          <p:nvPr/>
        </p:nvSpPr>
        <p:spPr>
          <a:xfrm>
            <a:off x="5260320" y="53499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  <a:ea typeface="Arial"/>
              </a:rPr>
              <a:t>p6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Picture 7" descr=""/>
          <p:cNvPicPr/>
          <p:nvPr/>
        </p:nvPicPr>
        <p:blipFill>
          <a:blip r:embed="rId2"/>
          <a:srcRect l="5505" t="1599" r="1712" b="53941"/>
          <a:stretch/>
        </p:blipFill>
        <p:spPr>
          <a:xfrm>
            <a:off x="1474920" y="1639800"/>
            <a:ext cx="3754440" cy="1944720"/>
          </a:xfrm>
          <a:prstGeom prst="rect">
            <a:avLst/>
          </a:prstGeom>
          <a:ln w="0">
            <a:noFill/>
          </a:ln>
        </p:spPr>
      </p:pic>
      <p:sp>
        <p:nvSpPr>
          <p:cNvPr id="85" name="CasellaDiTesto 65"/>
          <p:cNvSpPr/>
          <p:nvPr/>
        </p:nvSpPr>
        <p:spPr>
          <a:xfrm rot="19140600">
            <a:off x="4792320" y="5555520"/>
            <a:ext cx="40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Arial"/>
              </a:rPr>
              <a:t>FHI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CasellaDiTesto 70"/>
          <p:cNvSpPr/>
          <p:nvPr/>
        </p:nvSpPr>
        <p:spPr>
          <a:xfrm>
            <a:off x="4915080" y="587232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Connettore 1 71"/>
          <p:cNvSpPr/>
          <p:nvPr/>
        </p:nvSpPr>
        <p:spPr>
          <a:xfrm>
            <a:off x="5002200" y="5900760"/>
            <a:ext cx="1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6"/>
          <p:cNvSpPr/>
          <p:nvPr/>
        </p:nvSpPr>
        <p:spPr>
          <a:xfrm>
            <a:off x="259920" y="8661240"/>
            <a:ext cx="265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rtynova et al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</a:t>
            </a:r>
            <a:r>
              <a:rPr b="1" lang="it-IT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CasellaDiTesto 38"/>
          <p:cNvSpPr/>
          <p:nvPr/>
        </p:nvSpPr>
        <p:spPr>
          <a:xfrm rot="16200000">
            <a:off x="534600" y="4603680"/>
            <a:ext cx="1322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700" spc="-1" strike="noStrike">
                <a:solidFill>
                  <a:srgbClr val="000000"/>
                </a:solidFill>
                <a:latin typeface="Arial"/>
                <a:ea typeface="Arial"/>
              </a:rPr>
              <a:t>Fold enrichment over Flag a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6T13:24:38Z</dcterms:created>
  <dc:creator>Roberto Matovani</dc:creator>
  <dc:description/>
  <dc:language>en-US</dc:language>
  <cp:lastModifiedBy>Roberto Matovani</cp:lastModifiedBy>
  <dcterms:modified xsi:type="dcterms:W3CDTF">2012-02-07T17:01:31Z</dcterms:modified>
  <cp:revision>3</cp:revision>
  <dc:subject/>
  <dc:title>Slide 1</dc:title>
</cp:coreProperties>
</file>